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61" r:id="rId3"/>
    <p:sldId id="257" r:id="rId4"/>
    <p:sldId id="262" r:id="rId5"/>
    <p:sldId id="26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9766D"/>
    <a:srgbClr val="33CB2B"/>
    <a:srgbClr val="00B937"/>
    <a:srgbClr val="C1C2C3"/>
    <a:srgbClr val="609CFF"/>
    <a:srgbClr val="00BFC4"/>
    <a:srgbClr val="FF9D9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380"/>
    <p:restoredTop sz="85802"/>
  </p:normalViewPr>
  <p:slideViewPr>
    <p:cSldViewPr snapToGrid="0">
      <p:cViewPr varScale="1">
        <p:scale>
          <a:sx n="74" d="100"/>
          <a:sy n="74" d="100"/>
        </p:scale>
        <p:origin x="60" y="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A0ADFE-403C-D848-8A5D-DD42E1692DA9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AECD74-CC8B-9041-9D4C-ED3B52907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3495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2 Title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ogression-free survival and overall survival, all patients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2 Legend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. Progression-free survival. B. Overall survival. PFS, progression-free survival; OS, overall survival; CI, confidence interval</a:t>
            </a:r>
            <a:endParaRPr lang="en-US" b="1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AECD74-CC8B-9041-9D4C-ED3B5290755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2477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3 Title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ogression free survival and overall survival outcomes by subgroups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3 Legend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FS by (A) phase of trial, (C) PD-L1 tumor proportion score, and (E) histology. OS by (B) phase of trial, (D) PD-L1 tumor proportion score, and (F) histology. CI, confidence interval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AECD74-CC8B-9041-9D4C-ED3B5290755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5334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4 Title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aterfall plot of best change in tumor dimensions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4 Legend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aterfall plot of best change in tumor dimensions including all trial patients with baseline and at least one on-study CT assessment. Bars represent a single patient and are color coded by best response by RECIST 1.1 criteria. PR, partial response; SD, stable disease; PD, progression of disease; N/A, not available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AECD74-CC8B-9041-9D4C-ED3B5290755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51868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5 Title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ogression free survival and overall survival outcomes by rac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5 Legend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) Progression free survival subgroups by race. (B) Overall survival subgroups by race. AA, African American; CI, confidence interva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AECD74-CC8B-9041-9D4C-ED3B5290755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18673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6 Title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parison of pre-treatment baseline PD-L1 and Cycle 4 PD-L1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6 Legend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D-L1 tumor proportion scores (TPS) as assessed by central lab with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ako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22C3 from tumor biopsies. Cases with “-” had tissue submitted that could not be assessed for PD-L1. n/a indicates tissue was not available. Baseline cases with “*” indicate that tissue was not available for central PD-L1 testing and PD-L1 testing results were per local laboratory. PFS, progression free survival; SOD, sum of diameters;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o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months; LN</a:t>
            </a:r>
            <a:r>
              <a:rPr lang="en-US" sz="180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lymph node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AECD74-CC8B-9041-9D4C-ED3B5290755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9958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45FE3A-EBDB-D1F0-D889-9FF1B165F8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399163-82C1-B8F6-2E5A-9CC38264F6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8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2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DEA599-30EC-E27E-5BC9-AD3576682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D5DDE6-10F7-89D1-6AAE-DB8009E6DB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912CE6-FBCE-88E0-4F85-A35724604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821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AF8EE3-2623-A810-F01D-38A26A7DD8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1D78B8-619A-303B-C248-A2ECECB5E1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0143B8-76C5-42AA-CCC8-43E22774C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5690F4-2571-B663-221A-082DE31A5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5C0C4B-A5F4-AA99-676B-AD1E49008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605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5BAB945-7684-0E5C-5BAA-2BB56F47AE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1" y="365126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7906E9-79C0-FEAE-98FD-25663D92DE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6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2A384B-E5A2-1F46-8D2C-079758F9F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DE77BA-C7CB-58CB-A3EC-BA8D541CB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3EB8D2-B90B-2FE7-8DD6-F4DEBB08ED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527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F61940-BA70-A7A0-7F2C-412A903098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B8C0E1-6C41-5968-0A0C-99C0390DB8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5AA6C6-09E8-39DE-6583-EBC45AC4F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77E09C-265C-776D-26B0-FA5B14866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3E9F51-3255-F53E-FBDC-685ADA540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720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E1B164-1450-D5D6-9ACB-FF9E341928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C91B53-7451-35B4-1C22-8928D00A62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6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E1C12B-4352-5F9A-A1C4-F46E770E0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7CA302-88D5-9D26-DC94-FC71163DA9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62B9D6-88E2-9F93-8742-944BB2F8A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191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DAE730-C4FD-8DB6-854C-DEEB44E15C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DC33DF-2D73-9223-D7CB-9717F897DD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8B293C-6C62-6035-4318-7BA9C4A2E6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F204F5-900A-BE7F-0304-D80368603F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FB932E-DB57-C147-6DD4-A027975B0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93B2A0-5FCC-5E09-EAD9-9CCE3B80D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289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358500-4A80-08D5-54EB-33ACD5E593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8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CCAEAD-C0F6-24F9-45CF-1D3B36BE60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97E6F6-BC40-DC55-1504-B65924D032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265669B-6A00-2AE0-D0C3-C75A1CF4AF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DBEDB87-C73A-1589-C851-F2AEB90D3B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46B3441-E081-E31C-E694-545F51673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B4B10B8-6FAE-BD50-5D12-CE781B0BE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F967DB-EAD5-9902-A158-F8C4856C0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732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7D8DB9-95AF-B7A7-DDDB-65C8C73A38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4AF413-5685-365A-B7C9-AD3E8EEA4D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14BC8C7-51F0-7EB4-BEC1-6161E4C78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68F3E2-1DEF-5842-AE67-2E7523D30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052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4BA3FC-40C2-4B97-006C-5E883102E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00D27B-A6EA-6459-90C9-747E8E38B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BA8F5F-E828-CAC7-66E8-D24499B1C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370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BB49B5-9974-FD74-BA61-75606AE013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8D9C1C-C79E-3448-91EF-A03825C690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8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3DFB2D-F3C8-1A4C-039E-698982C8DA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44B224-7685-816D-24EC-5206ED09F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84B24C-3D21-5107-0363-AE6040E90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293710-FA36-3C1E-AC6C-D873D9976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077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DE4F6C-87ED-91DA-DE38-1BD6E978C6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4B6626-CAA2-6504-B6D5-C3FEAE745D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8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FC9233-10F7-60A9-BCC9-F6DB012AED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AF66E5-2ACF-010B-91E6-4F75DB1F2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2C2B38-E388-6B48-E5D1-2A01E3603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D657F2-1A40-D7CE-A48E-71484388C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768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BCA746-4E96-4B07-7039-73D273ED57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16CF73-D526-8E57-CB0C-7117EDC0AB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76E1E4-E36D-2A05-D470-D41B9F19B5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D6F9AD-0004-FA4F-9104-1B5D327263BB}" type="datetimeFigureOut">
              <a:rPr lang="en-US" smtClean="0"/>
              <a:t>6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DAC458-B5BA-57FB-CACD-2D705C20BC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8D0A96-DEB9-644B-2777-00B633BE02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971B6D-B7D1-DE4E-9870-D8B69A1F33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867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8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8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18" Type="http://schemas.openxmlformats.org/officeDocument/2006/relationships/image" Target="../media/image1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19" Type="http://schemas.openxmlformats.org/officeDocument/2006/relationships/image" Target="../media/image19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4933C059-68E1-0BC9-C7C0-5E7CFE2AA8C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447" r="14294" b="20031"/>
          <a:stretch/>
        </p:blipFill>
        <p:spPr>
          <a:xfrm>
            <a:off x="5928937" y="2072163"/>
            <a:ext cx="5586872" cy="2837001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D4807B3-1FC4-4011-E6DA-BCD0E2599D98}"/>
              </a:ext>
            </a:extLst>
          </p:cNvPr>
          <p:cNvSpPr txBox="1"/>
          <p:nvPr/>
        </p:nvSpPr>
        <p:spPr>
          <a:xfrm>
            <a:off x="5827290" y="172143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70C4925C-D3EC-46E1-1A69-173CEA89C7D4}"/>
              </a:ext>
            </a:extLst>
          </p:cNvPr>
          <p:cNvCxnSpPr>
            <a:cxnSpLocks/>
          </p:cNvCxnSpPr>
          <p:nvPr/>
        </p:nvCxnSpPr>
        <p:spPr>
          <a:xfrm flipV="1">
            <a:off x="7981491" y="3113104"/>
            <a:ext cx="0" cy="1262806"/>
          </a:xfrm>
          <a:prstGeom prst="line">
            <a:avLst/>
          </a:prstGeom>
          <a:ln w="19050">
            <a:solidFill>
              <a:schemeClr val="bg2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ACFCBE54-6C06-5817-547E-831E28FF8FB3}"/>
              </a:ext>
            </a:extLst>
          </p:cNvPr>
          <p:cNvSpPr txBox="1"/>
          <p:nvPr/>
        </p:nvSpPr>
        <p:spPr>
          <a:xfrm>
            <a:off x="7912803" y="2800351"/>
            <a:ext cx="543739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64%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9EC6EE4F-88F9-D454-EA7D-885D806EDF6E}"/>
              </a:ext>
            </a:extLst>
          </p:cNvPr>
          <p:cNvCxnSpPr>
            <a:cxnSpLocks/>
          </p:cNvCxnSpPr>
          <p:nvPr/>
        </p:nvCxnSpPr>
        <p:spPr>
          <a:xfrm flipV="1">
            <a:off x="8988230" y="3654522"/>
            <a:ext cx="0" cy="739869"/>
          </a:xfrm>
          <a:prstGeom prst="line">
            <a:avLst/>
          </a:prstGeom>
          <a:ln w="19050">
            <a:solidFill>
              <a:schemeClr val="bg2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032176D3-7C5A-989A-1433-EDA4FFF199AC}"/>
              </a:ext>
            </a:extLst>
          </p:cNvPr>
          <p:cNvSpPr txBox="1"/>
          <p:nvPr/>
        </p:nvSpPr>
        <p:spPr>
          <a:xfrm>
            <a:off x="8908146" y="3377983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33%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07054E6-04DA-75B4-BD3D-31E46956F51E}"/>
              </a:ext>
            </a:extLst>
          </p:cNvPr>
          <p:cNvCxnSpPr>
            <a:cxnSpLocks/>
          </p:cNvCxnSpPr>
          <p:nvPr/>
        </p:nvCxnSpPr>
        <p:spPr>
          <a:xfrm flipV="1">
            <a:off x="9994969" y="3847329"/>
            <a:ext cx="0" cy="542957"/>
          </a:xfrm>
          <a:prstGeom prst="line">
            <a:avLst/>
          </a:prstGeom>
          <a:ln w="28575">
            <a:solidFill>
              <a:schemeClr val="bg2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89CFEA93-F0EE-E977-38E9-66E9794E1974}"/>
              </a:ext>
            </a:extLst>
          </p:cNvPr>
          <p:cNvSpPr txBox="1"/>
          <p:nvPr/>
        </p:nvSpPr>
        <p:spPr>
          <a:xfrm>
            <a:off x="9794555" y="3516721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%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28106C9-6B93-8E1F-0609-7CA29AD6A853}"/>
              </a:ext>
            </a:extLst>
          </p:cNvPr>
          <p:cNvSpPr txBox="1"/>
          <p:nvPr/>
        </p:nvSpPr>
        <p:spPr>
          <a:xfrm>
            <a:off x="9240739" y="2295903"/>
            <a:ext cx="1935145" cy="52322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an OS: 15.4 </a:t>
            </a:r>
            <a:r>
              <a:rPr lang="en-US" sz="1400" b="1" dirty="0" err="1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lang="en-US" sz="14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4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95% CI: 12.4–28.1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8C36B75-A13C-C7CD-D1A3-8254800B0742}"/>
              </a:ext>
            </a:extLst>
          </p:cNvPr>
          <p:cNvSpPr txBox="1"/>
          <p:nvPr/>
        </p:nvSpPr>
        <p:spPr>
          <a:xfrm>
            <a:off x="8600869" y="4638344"/>
            <a:ext cx="2094174" cy="307777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D5D0BE1-698D-E329-2713-52023C4ED5F8}"/>
              </a:ext>
            </a:extLst>
          </p:cNvPr>
          <p:cNvSpPr txBox="1"/>
          <p:nvPr/>
        </p:nvSpPr>
        <p:spPr>
          <a:xfrm>
            <a:off x="5776152" y="2034260"/>
            <a:ext cx="400110" cy="2341650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B06F350-FBFB-4221-A301-0C273D41FD98}"/>
              </a:ext>
            </a:extLst>
          </p:cNvPr>
          <p:cNvSpPr txBox="1"/>
          <p:nvPr/>
        </p:nvSpPr>
        <p:spPr>
          <a:xfrm>
            <a:off x="5813842" y="4758318"/>
            <a:ext cx="2167649" cy="276999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EBB82A4E-622C-967C-81CA-112AB794548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2192"/>
          <a:stretch/>
        </p:blipFill>
        <p:spPr>
          <a:xfrm>
            <a:off x="949403" y="2129695"/>
            <a:ext cx="4159945" cy="2464344"/>
          </a:xfrm>
          <a:prstGeom prst="rect">
            <a:avLst/>
          </a:prstGeom>
        </p:spPr>
      </p:pic>
      <p:grpSp>
        <p:nvGrpSpPr>
          <p:cNvPr id="43" name="Group 42">
            <a:extLst>
              <a:ext uri="{FF2B5EF4-FFF2-40B4-BE49-F238E27FC236}">
                <a16:creationId xmlns:a16="http://schemas.microsoft.com/office/drawing/2014/main" id="{CB5F8E97-CAA6-A1E0-62C5-90285DA3309B}"/>
              </a:ext>
            </a:extLst>
          </p:cNvPr>
          <p:cNvGrpSpPr/>
          <p:nvPr/>
        </p:nvGrpSpPr>
        <p:grpSpPr>
          <a:xfrm>
            <a:off x="640408" y="1996558"/>
            <a:ext cx="4393435" cy="3004938"/>
            <a:chOff x="19432577" y="12076448"/>
            <a:chExt cx="11623739" cy="6995483"/>
          </a:xfrm>
        </p:grpSpPr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FDE455E0-D7EF-7F2B-758F-14300B6C024F}"/>
                </a:ext>
              </a:extLst>
            </p:cNvPr>
            <p:cNvGrpSpPr/>
            <p:nvPr/>
          </p:nvGrpSpPr>
          <p:grpSpPr>
            <a:xfrm>
              <a:off x="19432577" y="12076448"/>
              <a:ext cx="11623739" cy="6684414"/>
              <a:chOff x="19432577" y="12076448"/>
              <a:chExt cx="11623739" cy="6684414"/>
            </a:xfrm>
          </p:grpSpPr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3F9C66EB-F2F2-7FCA-3800-3F57E53DB77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983173" y="16343688"/>
                <a:ext cx="0" cy="1223883"/>
              </a:xfrm>
              <a:prstGeom prst="line">
                <a:avLst/>
              </a:prstGeom>
              <a:ln w="19050">
                <a:solidFill>
                  <a:schemeClr val="bg2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E94F74C5-0078-4F82-9EB4-38EE36E76F00}"/>
                  </a:ext>
                </a:extLst>
              </p:cNvPr>
              <p:cNvSpPr txBox="1"/>
              <p:nvPr/>
            </p:nvSpPr>
            <p:spPr>
              <a:xfrm>
                <a:off x="24546137" y="15609186"/>
                <a:ext cx="1298618" cy="64485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%</a:t>
                </a:r>
              </a:p>
            </p:txBody>
          </p: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745230CD-F442-63F7-2A61-5D946F66D6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645249" y="17215056"/>
                <a:ext cx="0" cy="352514"/>
              </a:xfrm>
              <a:prstGeom prst="line">
                <a:avLst/>
              </a:prstGeom>
              <a:ln w="19050">
                <a:solidFill>
                  <a:schemeClr val="bg2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BB45B8F5-8399-840D-C592-42C65A0BB8D5}"/>
                  </a:ext>
                </a:extLst>
              </p:cNvPr>
              <p:cNvSpPr txBox="1"/>
              <p:nvPr/>
            </p:nvSpPr>
            <p:spPr>
              <a:xfrm>
                <a:off x="27273469" y="16303613"/>
                <a:ext cx="1073839" cy="64485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%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07D13D21-D6AB-3840-D759-18A6A12C7257}"/>
                  </a:ext>
                </a:extLst>
              </p:cNvPr>
              <p:cNvSpPr txBox="1"/>
              <p:nvPr/>
            </p:nvSpPr>
            <p:spPr>
              <a:xfrm>
                <a:off x="25961937" y="12971339"/>
                <a:ext cx="5094379" cy="12180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dian PFS: 5.6 </a:t>
                </a:r>
                <a:r>
                  <a:rPr lang="en-US" sz="1400" b="1" dirty="0" err="1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o</a:t>
                </a:r>
                <a:r>
                  <a:rPr lang="en-US" sz="1400" b="1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r>
                  <a:rPr lang="en-US" sz="1400" b="1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95% CI: 4.6–8.2)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6EFD834B-4069-482A-0C12-6B0572C3C65B}"/>
                  </a:ext>
                </a:extLst>
              </p:cNvPr>
              <p:cNvSpPr txBox="1"/>
              <p:nvPr/>
            </p:nvSpPr>
            <p:spPr>
              <a:xfrm>
                <a:off x="25443381" y="18259309"/>
                <a:ext cx="1830085" cy="50155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2A0697EF-A49C-6B07-B970-A5855C5EA76B}"/>
                  </a:ext>
                </a:extLst>
              </p:cNvPr>
              <p:cNvSpPr txBox="1"/>
              <p:nvPr/>
            </p:nvSpPr>
            <p:spPr>
              <a:xfrm>
                <a:off x="19432577" y="12076448"/>
                <a:ext cx="570002" cy="604692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lIns="0" tIns="0" rIns="0" bIns="0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rogression-Free Survival</a:t>
                </a:r>
              </a:p>
            </p:txBody>
          </p:sp>
        </p:grp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C1B2C5C-CD5C-9468-E0A3-06272C106934}"/>
                </a:ext>
              </a:extLst>
            </p:cNvPr>
            <p:cNvSpPr txBox="1"/>
            <p:nvPr/>
          </p:nvSpPr>
          <p:spPr>
            <a:xfrm>
              <a:off x="19432577" y="18642029"/>
              <a:ext cx="2672965" cy="429902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umber at risk</a:t>
              </a:r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BDACF4FC-51E8-E60F-F62F-D484B33C27A9}"/>
              </a:ext>
            </a:extLst>
          </p:cNvPr>
          <p:cNvSpPr txBox="1"/>
          <p:nvPr/>
        </p:nvSpPr>
        <p:spPr>
          <a:xfrm>
            <a:off x="1188272" y="5116621"/>
            <a:ext cx="3921076" cy="153888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      46	                10	                    1                           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EEA8261-FE2E-3932-1A29-4837773E075D}"/>
              </a:ext>
            </a:extLst>
          </p:cNvPr>
          <p:cNvSpPr txBox="1"/>
          <p:nvPr/>
        </p:nvSpPr>
        <p:spPr>
          <a:xfrm>
            <a:off x="662209" y="172143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08317CF-906D-1AB6-F37E-E5BC323F8E97}"/>
              </a:ext>
            </a:extLst>
          </p:cNvPr>
          <p:cNvSpPr txBox="1"/>
          <p:nvPr/>
        </p:nvSpPr>
        <p:spPr>
          <a:xfrm>
            <a:off x="6482515" y="5115168"/>
            <a:ext cx="4851261" cy="153888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    46	               27	                  14                         7                           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3B1044D-6E0C-2226-FF04-2FCCD02253CC}"/>
              </a:ext>
            </a:extLst>
          </p:cNvPr>
          <p:cNvSpPr txBox="1"/>
          <p:nvPr/>
        </p:nvSpPr>
        <p:spPr>
          <a:xfrm>
            <a:off x="208892" y="158343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2</a:t>
            </a:r>
          </a:p>
        </p:txBody>
      </p:sp>
    </p:spTree>
    <p:extLst>
      <p:ext uri="{BB962C8B-B14F-4D97-AF65-F5344CB8AC3E}">
        <p14:creationId xmlns:p14="http://schemas.microsoft.com/office/powerpoint/2010/main" val="16549896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Picture 87">
            <a:extLst>
              <a:ext uri="{FF2B5EF4-FFF2-40B4-BE49-F238E27FC236}">
                <a16:creationId xmlns:a16="http://schemas.microsoft.com/office/drawing/2014/main" id="{2D250F72-45AF-F5C3-071C-695AB8B897E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531" r="14718" b="9471"/>
          <a:stretch/>
        </p:blipFill>
        <p:spPr>
          <a:xfrm>
            <a:off x="2125941" y="2204916"/>
            <a:ext cx="3602824" cy="1885388"/>
          </a:xfrm>
          <a:prstGeom prst="rect">
            <a:avLst/>
          </a:prstGeom>
        </p:spPr>
      </p:pic>
      <p:pic>
        <p:nvPicPr>
          <p:cNvPr id="103" name="Picture 102">
            <a:extLst>
              <a:ext uri="{FF2B5EF4-FFF2-40B4-BE49-F238E27FC236}">
                <a16:creationId xmlns:a16="http://schemas.microsoft.com/office/drawing/2014/main" id="{FF1F44DE-3A9E-C9D7-A88C-50432956B4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32248" y="2273086"/>
            <a:ext cx="3831726" cy="1833550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2F034219-D3DC-FAC0-7973-EE58F5E5605F}"/>
              </a:ext>
            </a:extLst>
          </p:cNvPr>
          <p:cNvGrpSpPr/>
          <p:nvPr/>
        </p:nvGrpSpPr>
        <p:grpSpPr>
          <a:xfrm>
            <a:off x="6038765" y="235939"/>
            <a:ext cx="4137870" cy="1821403"/>
            <a:chOff x="28720209" y="20283582"/>
            <a:chExt cx="7147223" cy="3674395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301D5E5-F2DC-6E3C-CEEE-F246819FB3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9990" b="30502"/>
            <a:stretch/>
          </p:blipFill>
          <p:spPr>
            <a:xfrm>
              <a:off x="28961037" y="20283582"/>
              <a:ext cx="6906395" cy="3344661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DB22518-49B5-4A3F-39B8-E8DC06909DEA}"/>
                </a:ext>
              </a:extLst>
            </p:cNvPr>
            <p:cNvSpPr txBox="1"/>
            <p:nvPr/>
          </p:nvSpPr>
          <p:spPr>
            <a:xfrm>
              <a:off x="28720209" y="20283582"/>
              <a:ext cx="279098" cy="3261207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lIns="0" tIns="0" rIns="0" bIns="0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8C1C3FC-A5CE-2D6D-8B15-FE2F17B704D5}"/>
                </a:ext>
              </a:extLst>
            </p:cNvPr>
            <p:cNvSpPr txBox="1"/>
            <p:nvPr/>
          </p:nvSpPr>
          <p:spPr>
            <a:xfrm>
              <a:off x="32263737" y="23632009"/>
              <a:ext cx="786302" cy="32596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</a:p>
          </p:txBody>
        </p:sp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34824945-12E2-1AEC-4EC5-E2B231DAD84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4194"/>
          <a:stretch/>
        </p:blipFill>
        <p:spPr>
          <a:xfrm>
            <a:off x="2199586" y="207849"/>
            <a:ext cx="3373268" cy="170396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27193CCA-5FE9-F1BA-DAF4-46B7DA4FC6C3}"/>
              </a:ext>
            </a:extLst>
          </p:cNvPr>
          <p:cNvSpPr txBox="1"/>
          <p:nvPr/>
        </p:nvSpPr>
        <p:spPr>
          <a:xfrm>
            <a:off x="3840448" y="1886516"/>
            <a:ext cx="455228" cy="161583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9D4B2F5-3873-361F-2B09-12E488B88A2F}"/>
              </a:ext>
            </a:extLst>
          </p:cNvPr>
          <p:cNvSpPr txBox="1"/>
          <p:nvPr/>
        </p:nvSpPr>
        <p:spPr>
          <a:xfrm>
            <a:off x="1974281" y="226241"/>
            <a:ext cx="161583" cy="1550256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B6EE21B-FF11-6D0A-05A3-84DC2C063563}"/>
              </a:ext>
            </a:extLst>
          </p:cNvPr>
          <p:cNvSpPr txBox="1"/>
          <p:nvPr/>
        </p:nvSpPr>
        <p:spPr>
          <a:xfrm>
            <a:off x="1639786" y="86301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79957B3-B694-E899-EC2B-C4A50685DB21}"/>
              </a:ext>
            </a:extLst>
          </p:cNvPr>
          <p:cNvSpPr txBox="1"/>
          <p:nvPr/>
        </p:nvSpPr>
        <p:spPr>
          <a:xfrm>
            <a:off x="5757298" y="66743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D8308C34-8747-6CD7-3824-8B3A3CCC85E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3665" r="15961"/>
          <a:stretch/>
        </p:blipFill>
        <p:spPr>
          <a:xfrm>
            <a:off x="2135864" y="4479417"/>
            <a:ext cx="3436990" cy="1933966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5E5D1BE0-6EB3-149A-4FDB-DFA311180DAB}"/>
              </a:ext>
            </a:extLst>
          </p:cNvPr>
          <p:cNvSpPr txBox="1"/>
          <p:nvPr/>
        </p:nvSpPr>
        <p:spPr>
          <a:xfrm>
            <a:off x="3838475" y="6400625"/>
            <a:ext cx="526696" cy="161583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37EB0CC-28DC-9C59-ACB0-88A85C474E02}"/>
              </a:ext>
            </a:extLst>
          </p:cNvPr>
          <p:cNvSpPr txBox="1"/>
          <p:nvPr/>
        </p:nvSpPr>
        <p:spPr>
          <a:xfrm>
            <a:off x="1626204" y="4559480"/>
            <a:ext cx="2744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68EFE39-37BF-F401-3826-282A1E839AC6}"/>
              </a:ext>
            </a:extLst>
          </p:cNvPr>
          <p:cNvSpPr txBox="1"/>
          <p:nvPr/>
        </p:nvSpPr>
        <p:spPr>
          <a:xfrm>
            <a:off x="1973949" y="4698729"/>
            <a:ext cx="161583" cy="1550257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57669F62-56EF-7619-8276-4FD8D3E4EE9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5431"/>
          <a:stretch/>
        </p:blipFill>
        <p:spPr>
          <a:xfrm>
            <a:off x="6167728" y="4554973"/>
            <a:ext cx="3675924" cy="1908210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6A4F08C2-3AE9-B419-8E08-AB7F95AFB00F}"/>
              </a:ext>
            </a:extLst>
          </p:cNvPr>
          <p:cNvSpPr txBox="1"/>
          <p:nvPr/>
        </p:nvSpPr>
        <p:spPr>
          <a:xfrm>
            <a:off x="5746699" y="4571281"/>
            <a:ext cx="2664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B1FE85E-55C9-D836-46E5-AAEE9021BD33}"/>
              </a:ext>
            </a:extLst>
          </p:cNvPr>
          <p:cNvSpPr txBox="1"/>
          <p:nvPr/>
        </p:nvSpPr>
        <p:spPr>
          <a:xfrm>
            <a:off x="6038765" y="4698729"/>
            <a:ext cx="161583" cy="1550257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0598DA1-25F3-2C3F-8077-A82DCDD54B1C}"/>
              </a:ext>
            </a:extLst>
          </p:cNvPr>
          <p:cNvSpPr txBox="1"/>
          <p:nvPr/>
        </p:nvSpPr>
        <p:spPr>
          <a:xfrm>
            <a:off x="8091374" y="6422348"/>
            <a:ext cx="439544" cy="161583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E67715C6-4854-B115-D869-CDBDDAE92B3F}"/>
              </a:ext>
            </a:extLst>
          </p:cNvPr>
          <p:cNvSpPr/>
          <p:nvPr/>
        </p:nvSpPr>
        <p:spPr>
          <a:xfrm>
            <a:off x="6899218" y="4212831"/>
            <a:ext cx="364221" cy="1588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B738E09F-1C09-D600-D859-2C8A320674C5}"/>
              </a:ext>
            </a:extLst>
          </p:cNvPr>
          <p:cNvSpPr/>
          <p:nvPr/>
        </p:nvSpPr>
        <p:spPr>
          <a:xfrm>
            <a:off x="9348886" y="4259420"/>
            <a:ext cx="626136" cy="1849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83DDA0EF-E18D-548C-3556-C4AC985F3BF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3845" t="816" r="26385" b="93232"/>
          <a:stretch/>
        </p:blipFill>
        <p:spPr>
          <a:xfrm>
            <a:off x="7513189" y="4619768"/>
            <a:ext cx="2035455" cy="133322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DE6EAD5D-1A73-FA69-A555-B9B0DE6483A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3845" t="816" r="26385" b="93232"/>
          <a:stretch/>
        </p:blipFill>
        <p:spPr>
          <a:xfrm>
            <a:off x="3181508" y="4625801"/>
            <a:ext cx="2035455" cy="133322"/>
          </a:xfrm>
          <a:prstGeom prst="rect">
            <a:avLst/>
          </a:prstGeom>
        </p:spPr>
      </p:pic>
      <p:grpSp>
        <p:nvGrpSpPr>
          <p:cNvPr id="75" name="Group 74">
            <a:extLst>
              <a:ext uri="{FF2B5EF4-FFF2-40B4-BE49-F238E27FC236}">
                <a16:creationId xmlns:a16="http://schemas.microsoft.com/office/drawing/2014/main" id="{B9B195BC-4441-115E-AADE-2D53493D2711}"/>
              </a:ext>
            </a:extLst>
          </p:cNvPr>
          <p:cNvGrpSpPr/>
          <p:nvPr/>
        </p:nvGrpSpPr>
        <p:grpSpPr>
          <a:xfrm>
            <a:off x="3282666" y="2458730"/>
            <a:ext cx="2464033" cy="149673"/>
            <a:chOff x="3238772" y="2646034"/>
            <a:chExt cx="2464033" cy="149673"/>
          </a:xfrm>
        </p:grpSpPr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61C97F72-FB74-372A-A84D-DB550CFFC5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9994" t="784" r="18014" b="94136"/>
            <a:stretch/>
          </p:blipFill>
          <p:spPr>
            <a:xfrm>
              <a:off x="3238772" y="2646034"/>
              <a:ext cx="2464033" cy="149673"/>
            </a:xfrm>
            <a:prstGeom prst="rect">
              <a:avLst/>
            </a:prstGeom>
          </p:spPr>
        </p:pic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B92FC2A-4A26-2816-40FE-B9EF08B96028}"/>
                </a:ext>
              </a:extLst>
            </p:cNvPr>
            <p:cNvSpPr txBox="1"/>
            <p:nvPr/>
          </p:nvSpPr>
          <p:spPr>
            <a:xfrm>
              <a:off x="3753527" y="2659204"/>
              <a:ext cx="26289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≥50%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CAB2C4A6-B099-820D-121B-4C3D714CF2C9}"/>
                </a:ext>
              </a:extLst>
            </p:cNvPr>
            <p:cNvSpPr txBox="1"/>
            <p:nvPr/>
          </p:nvSpPr>
          <p:spPr>
            <a:xfrm>
              <a:off x="4574159" y="2661785"/>
              <a:ext cx="32220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–49%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2B5D440E-D96C-DAAB-8919-C051EF98996C}"/>
                </a:ext>
              </a:extLst>
            </p:cNvPr>
            <p:cNvSpPr txBox="1"/>
            <p:nvPr/>
          </p:nvSpPr>
          <p:spPr>
            <a:xfrm>
              <a:off x="5418924" y="2661291"/>
              <a:ext cx="22275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&lt;1%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3110CE8-CCA1-F100-540D-2A81F95C5416}"/>
                </a:ext>
              </a:extLst>
            </p:cNvPr>
            <p:cNvSpPr txBox="1"/>
            <p:nvPr/>
          </p:nvSpPr>
          <p:spPr>
            <a:xfrm>
              <a:off x="3255175" y="2659203"/>
              <a:ext cx="291747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D-L1</a:t>
              </a:r>
            </a:p>
          </p:txBody>
        </p:sp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A32C6C4F-A5A8-660C-DF79-4687146A7603}"/>
              </a:ext>
            </a:extLst>
          </p:cNvPr>
          <p:cNvGrpSpPr/>
          <p:nvPr/>
        </p:nvGrpSpPr>
        <p:grpSpPr>
          <a:xfrm>
            <a:off x="7631566" y="2395270"/>
            <a:ext cx="2464033" cy="149673"/>
            <a:chOff x="3238772" y="2646034"/>
            <a:chExt cx="2464033" cy="149673"/>
          </a:xfrm>
        </p:grpSpPr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7A2AE18B-88E3-0413-4137-762F6F4196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9994" t="784" r="18014" b="94136"/>
            <a:stretch/>
          </p:blipFill>
          <p:spPr>
            <a:xfrm>
              <a:off x="3238772" y="2646034"/>
              <a:ext cx="2464033" cy="149673"/>
            </a:xfrm>
            <a:prstGeom prst="rect">
              <a:avLst/>
            </a:prstGeom>
          </p:spPr>
        </p:pic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93730DFE-1E22-558A-81E2-1276B82D531C}"/>
                </a:ext>
              </a:extLst>
            </p:cNvPr>
            <p:cNvSpPr txBox="1"/>
            <p:nvPr/>
          </p:nvSpPr>
          <p:spPr>
            <a:xfrm>
              <a:off x="3753527" y="2659204"/>
              <a:ext cx="26289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≥50%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3ED3BA2E-7B20-99AA-5F57-914D056431C8}"/>
                </a:ext>
              </a:extLst>
            </p:cNvPr>
            <p:cNvSpPr txBox="1"/>
            <p:nvPr/>
          </p:nvSpPr>
          <p:spPr>
            <a:xfrm>
              <a:off x="4574159" y="2661785"/>
              <a:ext cx="32220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–49%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24649B7F-6C93-27CC-3847-37EB1275B4D6}"/>
                </a:ext>
              </a:extLst>
            </p:cNvPr>
            <p:cNvSpPr txBox="1"/>
            <p:nvPr/>
          </p:nvSpPr>
          <p:spPr>
            <a:xfrm>
              <a:off x="5433288" y="2661291"/>
              <a:ext cx="208390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&lt;1%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67DF5C88-B8B1-6681-BF66-7309EB029EEF}"/>
                </a:ext>
              </a:extLst>
            </p:cNvPr>
            <p:cNvSpPr txBox="1"/>
            <p:nvPr/>
          </p:nvSpPr>
          <p:spPr>
            <a:xfrm>
              <a:off x="3255175" y="2659203"/>
              <a:ext cx="291747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D-L1</a:t>
              </a:r>
            </a:p>
          </p:txBody>
        </p:sp>
      </p:grpSp>
      <p:pic>
        <p:nvPicPr>
          <p:cNvPr id="82" name="Picture 81">
            <a:extLst>
              <a:ext uri="{FF2B5EF4-FFF2-40B4-BE49-F238E27FC236}">
                <a16:creationId xmlns:a16="http://schemas.microsoft.com/office/drawing/2014/main" id="{03306B2D-51B4-AC8B-A5F8-B2D3EA82E4E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4049" t="1345" r="11123" b="91863"/>
          <a:stretch/>
        </p:blipFill>
        <p:spPr>
          <a:xfrm>
            <a:off x="3351128" y="247394"/>
            <a:ext cx="1407582" cy="161582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434B8164-0E0E-E988-91BA-7B848D203EF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3821" t="945" r="11322" b="92182"/>
          <a:stretch/>
        </p:blipFill>
        <p:spPr>
          <a:xfrm>
            <a:off x="7607607" y="240210"/>
            <a:ext cx="1420580" cy="164896"/>
          </a:xfrm>
          <a:prstGeom prst="rect">
            <a:avLst/>
          </a:prstGeom>
        </p:spPr>
      </p:pic>
      <p:sp>
        <p:nvSpPr>
          <p:cNvPr id="84" name="TextBox 83">
            <a:extLst>
              <a:ext uri="{FF2B5EF4-FFF2-40B4-BE49-F238E27FC236}">
                <a16:creationId xmlns:a16="http://schemas.microsoft.com/office/drawing/2014/main" id="{CD9F7301-F500-ED7F-A03E-81439F4094D8}"/>
              </a:ext>
            </a:extLst>
          </p:cNvPr>
          <p:cNvSpPr txBox="1"/>
          <p:nvPr/>
        </p:nvSpPr>
        <p:spPr>
          <a:xfrm>
            <a:off x="2160049" y="1929081"/>
            <a:ext cx="806442" cy="184666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C1CB1160-1C4C-B685-81FC-F80FBA4653C5}"/>
              </a:ext>
            </a:extLst>
          </p:cNvPr>
          <p:cNvSpPr txBox="1"/>
          <p:nvPr/>
        </p:nvSpPr>
        <p:spPr>
          <a:xfrm>
            <a:off x="2014971" y="2058170"/>
            <a:ext cx="3507189" cy="184666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F9766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ase I          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4	                      2                              0                               0                               0</a:t>
            </a:r>
          </a:p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00BFC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ase II         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2	                      8                              1                               0                               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8CB71942-A2BB-82E9-AA81-9BC09D8A53F4}"/>
              </a:ext>
            </a:extLst>
          </p:cNvPr>
          <p:cNvSpPr txBox="1"/>
          <p:nvPr/>
        </p:nvSpPr>
        <p:spPr>
          <a:xfrm>
            <a:off x="2195440" y="4103315"/>
            <a:ext cx="806442" cy="184666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BA01CBF8-ACBA-C0E7-4F25-0F8CEA38CF9C}"/>
              </a:ext>
            </a:extLst>
          </p:cNvPr>
          <p:cNvSpPr txBox="1"/>
          <p:nvPr/>
        </p:nvSpPr>
        <p:spPr>
          <a:xfrm>
            <a:off x="2014971" y="4242857"/>
            <a:ext cx="3855320" cy="276999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F9766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  ≥50% 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	                      3                               1                               0                               0</a:t>
            </a:r>
          </a:p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00B93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 1-49% 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5	                      4                               0                               0                               0</a:t>
            </a:r>
          </a:p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609C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  &lt;1%   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9                              3                               0                               0                               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241A6A36-99E3-7FB3-0298-DE2BBEC12168}"/>
              </a:ext>
            </a:extLst>
          </p:cNvPr>
          <p:cNvSpPr txBox="1"/>
          <p:nvPr/>
        </p:nvSpPr>
        <p:spPr>
          <a:xfrm>
            <a:off x="2174350" y="6470899"/>
            <a:ext cx="806442" cy="184666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B8324CD0-380D-42DA-B7B4-11090A768F94}"/>
              </a:ext>
            </a:extLst>
          </p:cNvPr>
          <p:cNvSpPr txBox="1"/>
          <p:nvPr/>
        </p:nvSpPr>
        <p:spPr>
          <a:xfrm>
            <a:off x="2014971" y="6631759"/>
            <a:ext cx="3557883" cy="184666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F9766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enocarcinoma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  21	                     1                             0                               0                               0</a:t>
            </a:r>
          </a:p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00BFC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quamous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            21	                     8                             1                               0                               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BDCB1975-DD52-4591-2733-A69B7759AAAC}"/>
              </a:ext>
            </a:extLst>
          </p:cNvPr>
          <p:cNvSpPr txBox="1"/>
          <p:nvPr/>
        </p:nvSpPr>
        <p:spPr>
          <a:xfrm>
            <a:off x="6285423" y="6470899"/>
            <a:ext cx="806442" cy="184666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50EF6B4A-A08F-E7B5-5620-71B16436F8E1}"/>
              </a:ext>
            </a:extLst>
          </p:cNvPr>
          <p:cNvSpPr txBox="1"/>
          <p:nvPr/>
        </p:nvSpPr>
        <p:spPr>
          <a:xfrm>
            <a:off x="6309945" y="4112280"/>
            <a:ext cx="806442" cy="184666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D1D7832-9CCB-761C-E490-AF5440A3962B}"/>
              </a:ext>
            </a:extLst>
          </p:cNvPr>
          <p:cNvSpPr txBox="1"/>
          <p:nvPr/>
        </p:nvSpPr>
        <p:spPr>
          <a:xfrm>
            <a:off x="6285423" y="1933683"/>
            <a:ext cx="806442" cy="184666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E032963-DD2A-A99D-B686-D6230C386318}"/>
              </a:ext>
            </a:extLst>
          </p:cNvPr>
          <p:cNvSpPr txBox="1"/>
          <p:nvPr/>
        </p:nvSpPr>
        <p:spPr>
          <a:xfrm>
            <a:off x="6119702" y="4242857"/>
            <a:ext cx="3855320" cy="276999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F9766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  ≥50%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	                         4                                1                                  1                                   0</a:t>
            </a:r>
          </a:p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00B93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L1 1-49%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5	                        12                               3                                  2                                   0</a:t>
            </a:r>
          </a:p>
          <a:p>
            <a:r>
              <a:rPr lang="en-US" sz="600" dirty="0">
                <a:solidFill>
                  <a:srgbClr val="609C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D-L1  &lt;1%  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9                                 10                               5                                  2                                   0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E7CD501-18B2-BCC1-4151-EEF71DFE9475}"/>
              </a:ext>
            </a:extLst>
          </p:cNvPr>
          <p:cNvSpPr txBox="1"/>
          <p:nvPr/>
        </p:nvSpPr>
        <p:spPr>
          <a:xfrm>
            <a:off x="6167728" y="2058170"/>
            <a:ext cx="4050323" cy="184666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F9766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ase I          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4	                        8                                  3                                     1                                    1</a:t>
            </a:r>
          </a:p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00BFC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ase II                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2	                       19                                11                                    6                                    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79C4D44-8059-1088-BD38-6E0B66D5A808}"/>
              </a:ext>
            </a:extLst>
          </p:cNvPr>
          <p:cNvSpPr txBox="1"/>
          <p:nvPr/>
        </p:nvSpPr>
        <p:spPr>
          <a:xfrm>
            <a:off x="6119556" y="6631759"/>
            <a:ext cx="3557883" cy="184666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F9766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enocarcinoma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  21	                      11                             7                               4                               1</a:t>
            </a:r>
          </a:p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00BFC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quamous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            21	                      14                             6                               3                               0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2A2208CC-2CFF-C9CF-4490-6CB724531C19}"/>
              </a:ext>
            </a:extLst>
          </p:cNvPr>
          <p:cNvGrpSpPr/>
          <p:nvPr/>
        </p:nvGrpSpPr>
        <p:grpSpPr>
          <a:xfrm>
            <a:off x="3982933" y="477740"/>
            <a:ext cx="1445620" cy="535776"/>
            <a:chOff x="3470476" y="484109"/>
            <a:chExt cx="1445620" cy="535776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7720109-210D-F757-A954-D00B87AB75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r="67488"/>
            <a:stretch/>
          </p:blipFill>
          <p:spPr>
            <a:xfrm>
              <a:off x="3470476" y="484937"/>
              <a:ext cx="1334108" cy="534948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6BA8234C-B591-F92C-D202-70750969E7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63791" r="15898"/>
            <a:stretch/>
          </p:blipFill>
          <p:spPr>
            <a:xfrm>
              <a:off x="4082672" y="484109"/>
              <a:ext cx="833424" cy="534948"/>
            </a:xfrm>
            <a:prstGeom prst="rect">
              <a:avLst/>
            </a:prstGeom>
          </p:spPr>
        </p:pic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D8470782-C7CD-AA49-42DC-1C297C5EA0B5}"/>
              </a:ext>
            </a:extLst>
          </p:cNvPr>
          <p:cNvGrpSpPr/>
          <p:nvPr/>
        </p:nvGrpSpPr>
        <p:grpSpPr>
          <a:xfrm>
            <a:off x="8822840" y="435931"/>
            <a:ext cx="1369479" cy="529005"/>
            <a:chOff x="3982933" y="581888"/>
            <a:chExt cx="2595667" cy="1002660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EA171C31-6EB1-19D6-2833-F670F6351C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r="82835"/>
            <a:stretch/>
          </p:blipFill>
          <p:spPr>
            <a:xfrm>
              <a:off x="3982933" y="581888"/>
              <a:ext cx="1334108" cy="1001352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023B98E5-89EA-6505-C359-0E5334A13E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64530" r="16982"/>
            <a:stretch/>
          </p:blipFill>
          <p:spPr>
            <a:xfrm>
              <a:off x="5141645" y="583196"/>
              <a:ext cx="1436955" cy="1001352"/>
            </a:xfrm>
            <a:prstGeom prst="rect">
              <a:avLst/>
            </a:prstGeom>
          </p:spPr>
        </p:pic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90DB1F24-3DC7-7138-EDCF-DB91CECC2606}"/>
              </a:ext>
            </a:extLst>
          </p:cNvPr>
          <p:cNvGrpSpPr/>
          <p:nvPr/>
        </p:nvGrpSpPr>
        <p:grpSpPr>
          <a:xfrm>
            <a:off x="8549175" y="2609268"/>
            <a:ext cx="1643144" cy="552893"/>
            <a:chOff x="8549175" y="2609268"/>
            <a:chExt cx="1643144" cy="552893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4297013B-B0D6-4A06-010C-BE938FEC4296}"/>
                </a:ext>
              </a:extLst>
            </p:cNvPr>
            <p:cNvGrpSpPr/>
            <p:nvPr/>
          </p:nvGrpSpPr>
          <p:grpSpPr>
            <a:xfrm>
              <a:off x="8549175" y="2609268"/>
              <a:ext cx="1643144" cy="552893"/>
              <a:chOff x="2514600" y="4109836"/>
              <a:chExt cx="3755402" cy="1263635"/>
            </a:xfrm>
          </p:grpSpPr>
          <p:pic>
            <p:nvPicPr>
              <p:cNvPr id="34" name="Picture 33">
                <a:extLst>
                  <a:ext uri="{FF2B5EF4-FFF2-40B4-BE49-F238E27FC236}">
                    <a16:creationId xmlns:a16="http://schemas.microsoft.com/office/drawing/2014/main" id="{60B02828-D7E1-8489-5E6A-E6CBF918CD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65085" t="61454" r="4516"/>
              <a:stretch/>
            </p:blipFill>
            <p:spPr>
              <a:xfrm>
                <a:off x="3829173" y="4109836"/>
                <a:ext cx="2362776" cy="1263635"/>
              </a:xfrm>
              <a:prstGeom prst="rect">
                <a:avLst/>
              </a:prstGeom>
            </p:spPr>
          </p:pic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B0CFC8E3-1A02-6D90-7EBC-C26CDD19CE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t="62926" r="81006"/>
              <a:stretch/>
            </p:blipFill>
            <p:spPr>
              <a:xfrm>
                <a:off x="2514600" y="4157527"/>
                <a:ext cx="1476322" cy="1215390"/>
              </a:xfrm>
              <a:prstGeom prst="rect">
                <a:avLst/>
              </a:prstGeom>
            </p:spPr>
          </p:pic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23199B67-182B-832A-750C-23390F6CC87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86266" t="2991" b="90847"/>
              <a:stretch/>
            </p:blipFill>
            <p:spPr>
              <a:xfrm>
                <a:off x="5202503" y="4258770"/>
                <a:ext cx="1067499" cy="201994"/>
              </a:xfrm>
              <a:prstGeom prst="rect">
                <a:avLst/>
              </a:prstGeom>
            </p:spPr>
          </p:pic>
        </p:grpSp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DE6DADF8-6AB1-DA91-7F94-40D170BDF0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86266" t="10442" b="74169"/>
            <a:stretch/>
          </p:blipFill>
          <p:spPr>
            <a:xfrm>
              <a:off x="9720530" y="2777544"/>
              <a:ext cx="467075" cy="220739"/>
            </a:xfrm>
            <a:prstGeom prst="rect">
              <a:avLst/>
            </a:prstGeom>
          </p:spPr>
        </p:pic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88677DC1-8A8B-AFC7-53B3-3194992D1606}"/>
              </a:ext>
            </a:extLst>
          </p:cNvPr>
          <p:cNvGrpSpPr/>
          <p:nvPr/>
        </p:nvGrpSpPr>
        <p:grpSpPr>
          <a:xfrm>
            <a:off x="8128241" y="4863677"/>
            <a:ext cx="2089810" cy="506565"/>
            <a:chOff x="8128241" y="4882580"/>
            <a:chExt cx="2089810" cy="506565"/>
          </a:xfrm>
        </p:grpSpPr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7BEE0B4C-F970-CA5A-2DB1-68F54895630F}"/>
                </a:ext>
              </a:extLst>
            </p:cNvPr>
            <p:cNvGrpSpPr/>
            <p:nvPr/>
          </p:nvGrpSpPr>
          <p:grpSpPr>
            <a:xfrm>
              <a:off x="8128241" y="4882580"/>
              <a:ext cx="2089810" cy="506565"/>
              <a:chOff x="2209800" y="3850981"/>
              <a:chExt cx="4185201" cy="1014482"/>
            </a:xfrm>
          </p:grpSpPr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542D691A-7281-E039-5F26-55F5DF6844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t="65147" r="69258"/>
              <a:stretch/>
            </p:blipFill>
            <p:spPr>
              <a:xfrm>
                <a:off x="2209800" y="3864173"/>
                <a:ext cx="2389385" cy="1001290"/>
              </a:xfrm>
              <a:prstGeom prst="rect">
                <a:avLst/>
              </a:prstGeom>
            </p:spPr>
          </p:pic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7E83E51C-04AC-384C-AA33-F8174E5A0C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66039" t="64688" r="6060"/>
              <a:stretch/>
            </p:blipFill>
            <p:spPr>
              <a:xfrm>
                <a:off x="4226365" y="3850981"/>
                <a:ext cx="2168636" cy="1014482"/>
              </a:xfrm>
              <a:prstGeom prst="rect">
                <a:avLst/>
              </a:prstGeom>
            </p:spPr>
          </p:pic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id="{6E4408F5-35C2-8290-9D36-540AB199421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86087" t="12473" r="2799" b="73255"/>
              <a:stretch/>
            </p:blipFill>
            <p:spPr>
              <a:xfrm>
                <a:off x="5434402" y="4221122"/>
                <a:ext cx="863856" cy="410022"/>
              </a:xfrm>
              <a:prstGeom prst="rect">
                <a:avLst/>
              </a:prstGeom>
            </p:spPr>
          </p:pic>
        </p:grpSp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083DBA83-70E3-7FCD-0B09-27284A50DD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86087" t="2458" r="2799" b="89975"/>
            <a:stretch/>
          </p:blipFill>
          <p:spPr>
            <a:xfrm>
              <a:off x="9738392" y="4923736"/>
              <a:ext cx="431352" cy="108551"/>
            </a:xfrm>
            <a:prstGeom prst="rect">
              <a:avLst/>
            </a:prstGeom>
          </p:spPr>
        </p:pic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340BBF55-D812-771D-2D99-645DE173C012}"/>
              </a:ext>
            </a:extLst>
          </p:cNvPr>
          <p:cNvGrpSpPr/>
          <p:nvPr/>
        </p:nvGrpSpPr>
        <p:grpSpPr>
          <a:xfrm>
            <a:off x="3482248" y="4867471"/>
            <a:ext cx="2175385" cy="498978"/>
            <a:chOff x="3482248" y="4867471"/>
            <a:chExt cx="2175385" cy="498978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8E641035-A7D8-8EAE-6640-B32C19FD5199}"/>
                </a:ext>
              </a:extLst>
            </p:cNvPr>
            <p:cNvGrpSpPr/>
            <p:nvPr/>
          </p:nvGrpSpPr>
          <p:grpSpPr>
            <a:xfrm>
              <a:off x="3482248" y="4867471"/>
              <a:ext cx="2175385" cy="498978"/>
              <a:chOff x="1066230" y="4145312"/>
              <a:chExt cx="4446734" cy="1019967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03E42947-D2E2-6C9E-2D75-B2076F45C89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t="66037" r="70395"/>
              <a:stretch/>
            </p:blipFill>
            <p:spPr>
              <a:xfrm>
                <a:off x="1066230" y="4181460"/>
                <a:ext cx="2301030" cy="983819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D876221E-E9E8-49AE-B4C3-E970B054692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65308" t="64789" r="5528"/>
              <a:stretch/>
            </p:blipFill>
            <p:spPr>
              <a:xfrm>
                <a:off x="3246100" y="4145312"/>
                <a:ext cx="2266864" cy="1019967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5AFDBD86-7135-6635-69B0-CFB367290A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86994" t="14067" r="2161" b="72341"/>
              <a:stretch/>
            </p:blipFill>
            <p:spPr>
              <a:xfrm>
                <a:off x="4670147" y="4547708"/>
                <a:ext cx="842815" cy="393696"/>
              </a:xfrm>
              <a:prstGeom prst="rect">
                <a:avLst/>
              </a:prstGeom>
            </p:spPr>
          </p:pic>
        </p:grpSp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F8642845-C6D0-126B-3329-AC1F747F62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86994" t="3275" r="2161" b="89031"/>
            <a:stretch/>
          </p:blipFill>
          <p:spPr>
            <a:xfrm>
              <a:off x="5226362" y="4911386"/>
              <a:ext cx="412313" cy="109026"/>
            </a:xfrm>
            <a:prstGeom prst="rect">
              <a:avLst/>
            </a:prstGeom>
          </p:spPr>
        </p:pic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387C65CC-00B7-FF06-1014-A76F782BF118}"/>
              </a:ext>
            </a:extLst>
          </p:cNvPr>
          <p:cNvGrpSpPr/>
          <p:nvPr/>
        </p:nvGrpSpPr>
        <p:grpSpPr>
          <a:xfrm>
            <a:off x="3955321" y="2699035"/>
            <a:ext cx="1475766" cy="530727"/>
            <a:chOff x="3955321" y="2699035"/>
            <a:chExt cx="1475766" cy="530727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E3708722-7EA3-758A-3AC6-85EF92527192}"/>
                </a:ext>
              </a:extLst>
            </p:cNvPr>
            <p:cNvGrpSpPr/>
            <p:nvPr/>
          </p:nvGrpSpPr>
          <p:grpSpPr>
            <a:xfrm>
              <a:off x="3955321" y="2699035"/>
              <a:ext cx="1475766" cy="530727"/>
              <a:chOff x="2362200" y="3898525"/>
              <a:chExt cx="3410819" cy="1226626"/>
            </a:xfrm>
          </p:grpSpPr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055176EF-08A6-D6FB-DABE-07E9E6C36E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t="60271" r="78477"/>
              <a:stretch/>
            </p:blipFill>
            <p:spPr>
              <a:xfrm>
                <a:off x="2362200" y="3898525"/>
                <a:ext cx="1672842" cy="1226626"/>
              </a:xfrm>
              <a:prstGeom prst="rect">
                <a:avLst/>
              </a:prstGeom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16E927D3-120E-CFDA-5B55-F70238AF46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65646" t="60271" r="7347"/>
              <a:stretch/>
            </p:blipFill>
            <p:spPr>
              <a:xfrm>
                <a:off x="3673886" y="3898525"/>
                <a:ext cx="2099133" cy="1226626"/>
              </a:xfrm>
              <a:prstGeom prst="rect">
                <a:avLst/>
              </a:prstGeom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1BE6152C-82A4-0759-4C55-6B53EC9EE0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86879" t="11492" r="3328" b="66206"/>
              <a:stretch/>
            </p:blipFill>
            <p:spPr>
              <a:xfrm>
                <a:off x="5011840" y="4289895"/>
                <a:ext cx="761179" cy="688602"/>
              </a:xfrm>
              <a:prstGeom prst="rect">
                <a:avLst/>
              </a:prstGeom>
            </p:spPr>
          </p:pic>
        </p:grpSp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1B71BCD6-B55D-E22A-37CD-858CB0A732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86879" t="3590" r="3328" b="90914"/>
            <a:stretch/>
          </p:blipFill>
          <p:spPr>
            <a:xfrm>
              <a:off x="5101746" y="2761087"/>
              <a:ext cx="329341" cy="73416"/>
            </a:xfrm>
            <a:prstGeom prst="rect">
              <a:avLst/>
            </a:prstGeom>
          </p:spPr>
        </p:pic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41CC8A8C-3782-15A7-D204-67B11CE84B22}"/>
              </a:ext>
            </a:extLst>
          </p:cNvPr>
          <p:cNvSpPr txBox="1"/>
          <p:nvPr/>
        </p:nvSpPr>
        <p:spPr>
          <a:xfrm>
            <a:off x="208892" y="158343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3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7939A96-D6F8-7667-A687-3FE9F476BBBF}"/>
              </a:ext>
            </a:extLst>
          </p:cNvPr>
          <p:cNvSpPr txBox="1"/>
          <p:nvPr/>
        </p:nvSpPr>
        <p:spPr>
          <a:xfrm>
            <a:off x="3821640" y="4077722"/>
            <a:ext cx="455228" cy="161583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C6CC7F2D-9080-7153-B0C4-95B220EE550C}"/>
              </a:ext>
            </a:extLst>
          </p:cNvPr>
          <p:cNvSpPr txBox="1"/>
          <p:nvPr/>
        </p:nvSpPr>
        <p:spPr>
          <a:xfrm>
            <a:off x="1973949" y="2433007"/>
            <a:ext cx="161583" cy="1550256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A4F7AF8-3793-EDA5-4A93-1B4FB3E7F312}"/>
              </a:ext>
            </a:extLst>
          </p:cNvPr>
          <p:cNvSpPr txBox="1"/>
          <p:nvPr/>
        </p:nvSpPr>
        <p:spPr>
          <a:xfrm>
            <a:off x="4089546" y="2947642"/>
            <a:ext cx="265606" cy="2308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≥50%   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-49%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&lt;1%</a:t>
            </a:r>
          </a:p>
        </p:txBody>
      </p:sp>
      <p:pic>
        <p:nvPicPr>
          <p:cNvPr id="99" name="Picture 98">
            <a:extLst>
              <a:ext uri="{FF2B5EF4-FFF2-40B4-BE49-F238E27FC236}">
                <a16:creationId xmlns:a16="http://schemas.microsoft.com/office/drawing/2014/main" id="{A9AE0D39-4907-4488-62F8-01FCDE38825C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43862" b="7011"/>
          <a:stretch/>
        </p:blipFill>
        <p:spPr>
          <a:xfrm>
            <a:off x="4527804" y="2935194"/>
            <a:ext cx="620272" cy="260729"/>
          </a:xfrm>
          <a:prstGeom prst="rect">
            <a:avLst/>
          </a:prstGeom>
        </p:spPr>
      </p:pic>
      <p:pic>
        <p:nvPicPr>
          <p:cNvPr id="101" name="Picture 100">
            <a:extLst>
              <a:ext uri="{FF2B5EF4-FFF2-40B4-BE49-F238E27FC236}">
                <a16:creationId xmlns:a16="http://schemas.microsoft.com/office/drawing/2014/main" id="{01D2806D-A105-8A2C-007C-3500ED051045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20213" t="44567" r="7316"/>
          <a:stretch/>
        </p:blipFill>
        <p:spPr>
          <a:xfrm>
            <a:off x="5078845" y="2862217"/>
            <a:ext cx="357195" cy="210078"/>
          </a:xfrm>
          <a:prstGeom prst="rect">
            <a:avLst/>
          </a:prstGeom>
        </p:spPr>
      </p:pic>
      <p:sp>
        <p:nvSpPr>
          <p:cNvPr id="104" name="TextBox 103">
            <a:extLst>
              <a:ext uri="{FF2B5EF4-FFF2-40B4-BE49-F238E27FC236}">
                <a16:creationId xmlns:a16="http://schemas.microsoft.com/office/drawing/2014/main" id="{E953C1DA-48D8-5DAB-EF60-DDEDEDE1DA90}"/>
              </a:ext>
            </a:extLst>
          </p:cNvPr>
          <p:cNvSpPr txBox="1"/>
          <p:nvPr/>
        </p:nvSpPr>
        <p:spPr>
          <a:xfrm>
            <a:off x="6043119" y="2192056"/>
            <a:ext cx="161583" cy="1616585"/>
          </a:xfrm>
          <a:prstGeom prst="rect">
            <a:avLst/>
          </a:prstGeom>
          <a:solidFill>
            <a:schemeClr val="bg1"/>
          </a:solidFill>
        </p:spPr>
        <p:txBody>
          <a:bodyPr vert="vert270" wrap="square" lIns="0" tIns="0" rIns="0" bIns="0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3133DDC7-20C3-EA20-DEF0-3BE048BF47E3}"/>
              </a:ext>
            </a:extLst>
          </p:cNvPr>
          <p:cNvSpPr txBox="1"/>
          <p:nvPr/>
        </p:nvSpPr>
        <p:spPr>
          <a:xfrm>
            <a:off x="8092855" y="4073672"/>
            <a:ext cx="455228" cy="161583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0" rIns="0" bIns="0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</a:p>
        </p:txBody>
      </p:sp>
      <p:pic>
        <p:nvPicPr>
          <p:cNvPr id="107" name="Picture 106">
            <a:extLst>
              <a:ext uri="{FF2B5EF4-FFF2-40B4-BE49-F238E27FC236}">
                <a16:creationId xmlns:a16="http://schemas.microsoft.com/office/drawing/2014/main" id="{52152FFD-2A9C-EB27-A44D-3ED66EEA9263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t="56912"/>
          <a:stretch/>
        </p:blipFill>
        <p:spPr>
          <a:xfrm>
            <a:off x="9783135" y="2777543"/>
            <a:ext cx="275758" cy="118819"/>
          </a:xfrm>
          <a:prstGeom prst="rect">
            <a:avLst/>
          </a:prstGeom>
        </p:spPr>
      </p:pic>
      <p:sp>
        <p:nvSpPr>
          <p:cNvPr id="108" name="TextBox 107">
            <a:extLst>
              <a:ext uri="{FF2B5EF4-FFF2-40B4-BE49-F238E27FC236}">
                <a16:creationId xmlns:a16="http://schemas.microsoft.com/office/drawing/2014/main" id="{EC682DE6-6A0E-9E51-7E0B-E16F9EF4DB3A}"/>
              </a:ext>
            </a:extLst>
          </p:cNvPr>
          <p:cNvSpPr txBox="1"/>
          <p:nvPr/>
        </p:nvSpPr>
        <p:spPr>
          <a:xfrm>
            <a:off x="8660037" y="2873239"/>
            <a:ext cx="265606" cy="230832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≥50%   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-49%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&lt;1%</a:t>
            </a:r>
          </a:p>
        </p:txBody>
      </p:sp>
      <p:pic>
        <p:nvPicPr>
          <p:cNvPr id="110" name="Picture 109">
            <a:extLst>
              <a:ext uri="{FF2B5EF4-FFF2-40B4-BE49-F238E27FC236}">
                <a16:creationId xmlns:a16="http://schemas.microsoft.com/office/drawing/2014/main" id="{9A245EB6-001F-FE82-4A12-CF2FB89D7D68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t="40533" b="10727"/>
          <a:stretch/>
        </p:blipFill>
        <p:spPr>
          <a:xfrm>
            <a:off x="9151070" y="2844880"/>
            <a:ext cx="551905" cy="259192"/>
          </a:xfrm>
          <a:prstGeom prst="rect">
            <a:avLst/>
          </a:prstGeom>
        </p:spPr>
      </p:pic>
      <p:sp>
        <p:nvSpPr>
          <p:cNvPr id="111" name="TextBox 110">
            <a:extLst>
              <a:ext uri="{FF2B5EF4-FFF2-40B4-BE49-F238E27FC236}">
                <a16:creationId xmlns:a16="http://schemas.microsoft.com/office/drawing/2014/main" id="{41D6A0FC-294C-A61F-C507-7E70A971612A}"/>
              </a:ext>
            </a:extLst>
          </p:cNvPr>
          <p:cNvSpPr txBox="1"/>
          <p:nvPr/>
        </p:nvSpPr>
        <p:spPr>
          <a:xfrm>
            <a:off x="1623610" y="2217045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B0B099C0-0836-F79B-AABC-E1632EDF95B7}"/>
              </a:ext>
            </a:extLst>
          </p:cNvPr>
          <p:cNvSpPr txBox="1"/>
          <p:nvPr/>
        </p:nvSpPr>
        <p:spPr>
          <a:xfrm>
            <a:off x="5757298" y="2245723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8905515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92910252-4D53-B99D-0BF3-306341DAE21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635"/>
          <a:stretch/>
        </p:blipFill>
        <p:spPr>
          <a:xfrm>
            <a:off x="2398902" y="993025"/>
            <a:ext cx="7394201" cy="487195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67F2040-04EC-44EA-F1F7-E47BD9DF59D1}"/>
              </a:ext>
            </a:extLst>
          </p:cNvPr>
          <p:cNvSpPr txBox="1"/>
          <p:nvPr/>
        </p:nvSpPr>
        <p:spPr>
          <a:xfrm>
            <a:off x="208892" y="158343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4</a:t>
            </a:r>
          </a:p>
        </p:txBody>
      </p:sp>
    </p:spTree>
    <p:extLst>
      <p:ext uri="{BB962C8B-B14F-4D97-AF65-F5344CB8AC3E}">
        <p14:creationId xmlns:p14="http://schemas.microsoft.com/office/powerpoint/2010/main" val="18705670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100DB830-11BD-B50A-0237-692CDB2DD4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84357" y="1628440"/>
            <a:ext cx="5815134" cy="452467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9F4EA26-FAEE-2E3A-8E2C-34F401BC7731}"/>
              </a:ext>
            </a:extLst>
          </p:cNvPr>
          <p:cNvSpPr txBox="1"/>
          <p:nvPr/>
        </p:nvSpPr>
        <p:spPr>
          <a:xfrm>
            <a:off x="16258" y="123240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B39316-17FD-D11C-9E40-34340659BCC8}"/>
              </a:ext>
            </a:extLst>
          </p:cNvPr>
          <p:cNvSpPr txBox="1"/>
          <p:nvPr/>
        </p:nvSpPr>
        <p:spPr>
          <a:xfrm>
            <a:off x="5769847" y="123240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9987237-1FCC-2C0E-9D9E-812F64A59D29}"/>
              </a:ext>
            </a:extLst>
          </p:cNvPr>
          <p:cNvSpPr txBox="1"/>
          <p:nvPr/>
        </p:nvSpPr>
        <p:spPr>
          <a:xfrm>
            <a:off x="9224386" y="4656660"/>
            <a:ext cx="1882059" cy="369332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r>
              <a:rPr lang="en-US" dirty="0"/>
              <a:t>Month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2D5B257-9E71-F49E-CEB1-D160227BE588}"/>
              </a:ext>
            </a:extLst>
          </p:cNvPr>
          <p:cNvSpPr txBox="1"/>
          <p:nvPr/>
        </p:nvSpPr>
        <p:spPr>
          <a:xfrm>
            <a:off x="4151806" y="2116157"/>
            <a:ext cx="835485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p=0.45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6B9011D5-3FEA-F9B0-F0AB-91987FC27E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258" y="1628441"/>
            <a:ext cx="5815133" cy="452467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4B3380A-EE1F-1328-C0EF-01F8C8EC285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69057"/>
          <a:stretch/>
        </p:blipFill>
        <p:spPr>
          <a:xfrm>
            <a:off x="3033643" y="2256000"/>
            <a:ext cx="1297058" cy="86177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B87BC2A2-886D-D107-CC54-A3732B96DB9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1650"/>
          <a:stretch/>
        </p:blipFill>
        <p:spPr>
          <a:xfrm>
            <a:off x="4330700" y="2256000"/>
            <a:ext cx="1188370" cy="861774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C41B397A-2D91-2A2D-277F-5778628DC9E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67910"/>
          <a:stretch/>
        </p:blipFill>
        <p:spPr>
          <a:xfrm>
            <a:off x="9224387" y="2140052"/>
            <a:ext cx="1315003" cy="842449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E9EC731D-A614-31E3-B32E-3102741C89A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2324"/>
          <a:stretch/>
        </p:blipFill>
        <p:spPr>
          <a:xfrm>
            <a:off x="10539390" y="2140052"/>
            <a:ext cx="1134111" cy="842449"/>
          </a:xfrm>
          <a:prstGeom prst="rect">
            <a:avLst/>
          </a:prstGeom>
        </p:spPr>
      </p:pic>
      <p:sp>
        <p:nvSpPr>
          <p:cNvPr id="27" name="Rectangle 26">
            <a:extLst>
              <a:ext uri="{FF2B5EF4-FFF2-40B4-BE49-F238E27FC236}">
                <a16:creationId xmlns:a16="http://schemas.microsoft.com/office/drawing/2014/main" id="{22E22CC4-2B19-589F-63F0-C021B7268A41}"/>
              </a:ext>
            </a:extLst>
          </p:cNvPr>
          <p:cNvSpPr/>
          <p:nvPr/>
        </p:nvSpPr>
        <p:spPr>
          <a:xfrm>
            <a:off x="2022764" y="1708727"/>
            <a:ext cx="461818" cy="1847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F07A3F1-E04E-9E60-6580-FFEBCDC67102}"/>
              </a:ext>
            </a:extLst>
          </p:cNvPr>
          <p:cNvSpPr/>
          <p:nvPr/>
        </p:nvSpPr>
        <p:spPr>
          <a:xfrm>
            <a:off x="8077201" y="1708727"/>
            <a:ext cx="461818" cy="1847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7D7A26B-8E26-7FD1-72E6-09256A7E547F}"/>
              </a:ext>
            </a:extLst>
          </p:cNvPr>
          <p:cNvSpPr txBox="1"/>
          <p:nvPr/>
        </p:nvSpPr>
        <p:spPr>
          <a:xfrm>
            <a:off x="3134786" y="4704620"/>
            <a:ext cx="1882059" cy="369332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r>
              <a:rPr lang="en-US" dirty="0"/>
              <a:t>Month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A1584E5-A862-6B05-7B66-D309AD085875}"/>
              </a:ext>
            </a:extLst>
          </p:cNvPr>
          <p:cNvSpPr txBox="1"/>
          <p:nvPr/>
        </p:nvSpPr>
        <p:spPr>
          <a:xfrm>
            <a:off x="208892" y="158343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5</a:t>
            </a:r>
          </a:p>
        </p:txBody>
      </p:sp>
    </p:spTree>
    <p:extLst>
      <p:ext uri="{BB962C8B-B14F-4D97-AF65-F5344CB8AC3E}">
        <p14:creationId xmlns:p14="http://schemas.microsoft.com/office/powerpoint/2010/main" val="21419750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E292154-C435-55C2-4CE3-2F775221FC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050717"/>
              </p:ext>
            </p:extLst>
          </p:nvPr>
        </p:nvGraphicFramePr>
        <p:xfrm>
          <a:off x="548643" y="620743"/>
          <a:ext cx="10741873" cy="362301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84136">
                  <a:extLst>
                    <a:ext uri="{9D8B030D-6E8A-4147-A177-3AD203B41FA5}">
                      <a16:colId xmlns:a16="http://schemas.microsoft.com/office/drawing/2014/main" val="3662609655"/>
                    </a:ext>
                  </a:extLst>
                </a:gridCol>
                <a:gridCol w="973047">
                  <a:extLst>
                    <a:ext uri="{9D8B030D-6E8A-4147-A177-3AD203B41FA5}">
                      <a16:colId xmlns:a16="http://schemas.microsoft.com/office/drawing/2014/main" val="4105368541"/>
                    </a:ext>
                  </a:extLst>
                </a:gridCol>
                <a:gridCol w="1014971">
                  <a:extLst>
                    <a:ext uri="{9D8B030D-6E8A-4147-A177-3AD203B41FA5}">
                      <a16:colId xmlns:a16="http://schemas.microsoft.com/office/drawing/2014/main" val="1119153571"/>
                    </a:ext>
                  </a:extLst>
                </a:gridCol>
                <a:gridCol w="1014971">
                  <a:extLst>
                    <a:ext uri="{9D8B030D-6E8A-4147-A177-3AD203B41FA5}">
                      <a16:colId xmlns:a16="http://schemas.microsoft.com/office/drawing/2014/main" val="809097799"/>
                    </a:ext>
                  </a:extLst>
                </a:gridCol>
                <a:gridCol w="939690">
                  <a:extLst>
                    <a:ext uri="{9D8B030D-6E8A-4147-A177-3AD203B41FA5}">
                      <a16:colId xmlns:a16="http://schemas.microsoft.com/office/drawing/2014/main" val="3096248234"/>
                    </a:ext>
                  </a:extLst>
                </a:gridCol>
                <a:gridCol w="939690">
                  <a:extLst>
                    <a:ext uri="{9D8B030D-6E8A-4147-A177-3AD203B41FA5}">
                      <a16:colId xmlns:a16="http://schemas.microsoft.com/office/drawing/2014/main" val="320038571"/>
                    </a:ext>
                  </a:extLst>
                </a:gridCol>
                <a:gridCol w="524646">
                  <a:extLst>
                    <a:ext uri="{9D8B030D-6E8A-4147-A177-3AD203B41FA5}">
                      <a16:colId xmlns:a16="http://schemas.microsoft.com/office/drawing/2014/main" val="3628104997"/>
                    </a:ext>
                  </a:extLst>
                </a:gridCol>
                <a:gridCol w="1379532">
                  <a:extLst>
                    <a:ext uri="{9D8B030D-6E8A-4147-A177-3AD203B41FA5}">
                      <a16:colId xmlns:a16="http://schemas.microsoft.com/office/drawing/2014/main" val="3576794721"/>
                    </a:ext>
                  </a:extLst>
                </a:gridCol>
                <a:gridCol w="3371190">
                  <a:extLst>
                    <a:ext uri="{9D8B030D-6E8A-4147-A177-3AD203B41FA5}">
                      <a16:colId xmlns:a16="http://schemas.microsoft.com/office/drawing/2014/main" val="1158781508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 PD-L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 biopsy site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 4</a:t>
                      </a:r>
                    </a:p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L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psy #2 site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nge in </a:t>
                      </a:r>
                    </a:p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L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C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S</a:t>
                      </a:r>
                    </a:p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 change in SOD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es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3145696"/>
                  </a:ext>
                </a:extLst>
              </a:tr>
              <a:tr h="3483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US" sz="16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C1C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3.6%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79918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N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C1C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25666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C1C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37452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*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50</a:t>
                      </a:r>
                    </a:p>
                  </a:txBody>
                  <a:tcPr marL="9525" marR="9525" marT="9525" marB="0" anchor="ctr">
                    <a:solidFill>
                      <a:srgbClr val="33CB2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%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860255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C1C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70158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C1C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449946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N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C1C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3.8%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422847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C1C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11507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*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9</a:t>
                      </a:r>
                    </a:p>
                  </a:txBody>
                  <a:tcPr marL="9525" marR="9525" marT="9525" marB="0" anchor="ctr">
                    <a:solidFill>
                      <a:srgbClr val="F9766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9.2%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21506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C1C2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96434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99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33CB2B">
                        <a:alpha val="8588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7.6%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568113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AEB4AB1-D6C7-7126-9163-BA744C1CFADA}"/>
              </a:ext>
            </a:extLst>
          </p:cNvPr>
          <p:cNvSpPr txBox="1"/>
          <p:nvPr/>
        </p:nvSpPr>
        <p:spPr>
          <a:xfrm>
            <a:off x="8017261" y="1948922"/>
            <a:ext cx="3850031" cy="18158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Cycle 4 Biopsy Totals (phase II only):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tal obtained	11/32 (34%)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ssessable 	5/11 (45%)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u="sng" dirty="0">
                <a:latin typeface="Arial" panose="020B0604020202020204" pitchFamily="34" charset="0"/>
                <a:cs typeface="Arial" panose="020B0604020202020204" pitchFamily="34" charset="0"/>
              </a:rPr>
              <a:t>Change in PD-L1</a:t>
            </a:r>
          </a:p>
          <a:p>
            <a:r>
              <a:rPr lang="en-US" sz="1400" dirty="0">
                <a:solidFill>
                  <a:srgbClr val="33CB2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reased		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/5  (40%)</a:t>
            </a:r>
          </a:p>
          <a:p>
            <a:r>
              <a:rPr lang="en-US" sz="1400" dirty="0">
                <a:solidFill>
                  <a:srgbClr val="FA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creased  	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/5  (20%)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 Change 	2/5  (40%)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8EAA8F3-F84E-2807-F782-13940E6034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0022838"/>
              </p:ext>
            </p:extLst>
          </p:nvPr>
        </p:nvGraphicFramePr>
        <p:xfrm>
          <a:off x="548643" y="4639998"/>
          <a:ext cx="10622939" cy="151066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89270">
                  <a:extLst>
                    <a:ext uri="{9D8B030D-6E8A-4147-A177-3AD203B41FA5}">
                      <a16:colId xmlns:a16="http://schemas.microsoft.com/office/drawing/2014/main" val="3662609655"/>
                    </a:ext>
                  </a:extLst>
                </a:gridCol>
                <a:gridCol w="981598">
                  <a:extLst>
                    <a:ext uri="{9D8B030D-6E8A-4147-A177-3AD203B41FA5}">
                      <a16:colId xmlns:a16="http://schemas.microsoft.com/office/drawing/2014/main" val="4105368541"/>
                    </a:ext>
                  </a:extLst>
                </a:gridCol>
                <a:gridCol w="1023890">
                  <a:extLst>
                    <a:ext uri="{9D8B030D-6E8A-4147-A177-3AD203B41FA5}">
                      <a16:colId xmlns:a16="http://schemas.microsoft.com/office/drawing/2014/main" val="1172683159"/>
                    </a:ext>
                  </a:extLst>
                </a:gridCol>
                <a:gridCol w="1023890">
                  <a:extLst>
                    <a:ext uri="{9D8B030D-6E8A-4147-A177-3AD203B41FA5}">
                      <a16:colId xmlns:a16="http://schemas.microsoft.com/office/drawing/2014/main" val="809097799"/>
                    </a:ext>
                  </a:extLst>
                </a:gridCol>
                <a:gridCol w="947949">
                  <a:extLst>
                    <a:ext uri="{9D8B030D-6E8A-4147-A177-3AD203B41FA5}">
                      <a16:colId xmlns:a16="http://schemas.microsoft.com/office/drawing/2014/main" val="3837153599"/>
                    </a:ext>
                  </a:extLst>
                </a:gridCol>
                <a:gridCol w="947949">
                  <a:extLst>
                    <a:ext uri="{9D8B030D-6E8A-4147-A177-3AD203B41FA5}">
                      <a16:colId xmlns:a16="http://schemas.microsoft.com/office/drawing/2014/main" val="320038571"/>
                    </a:ext>
                  </a:extLst>
                </a:gridCol>
                <a:gridCol w="947949">
                  <a:extLst>
                    <a:ext uri="{9D8B030D-6E8A-4147-A177-3AD203B41FA5}">
                      <a16:colId xmlns:a16="http://schemas.microsoft.com/office/drawing/2014/main" val="1383049364"/>
                    </a:ext>
                  </a:extLst>
                </a:gridCol>
                <a:gridCol w="947949">
                  <a:extLst>
                    <a:ext uri="{9D8B030D-6E8A-4147-A177-3AD203B41FA5}">
                      <a16:colId xmlns:a16="http://schemas.microsoft.com/office/drawing/2014/main" val="2772716120"/>
                    </a:ext>
                  </a:extLst>
                </a:gridCol>
                <a:gridCol w="3212495">
                  <a:extLst>
                    <a:ext uri="{9D8B030D-6E8A-4147-A177-3AD203B41FA5}">
                      <a16:colId xmlns:a16="http://schemas.microsoft.com/office/drawing/2014/main" val="1158781508"/>
                    </a:ext>
                  </a:extLst>
                </a:gridCol>
              </a:tblGrid>
              <a:tr h="190500">
                <a:tc gridSpan="9">
                  <a:txBody>
                    <a:bodyPr/>
                    <a:lstStyle/>
                    <a:p>
                      <a:pPr algn="ctr" fontAlgn="b"/>
                      <a:r>
                        <a:rPr lang="en-US" sz="1600" b="0" i="0" u="sng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 without cycle 4 biopsy and additional info was provided</a:t>
                      </a:r>
                    </a:p>
                    <a:p>
                      <a:pPr algn="ctr" fontAlgn="b"/>
                      <a:endParaRPr lang="en-US" sz="1600" b="0" i="0" u="sng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C1C2C3">
                        <a:alpha val="85882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98067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solidFill>
                      <a:srgbClr val="C1C2C3">
                        <a:alpha val="8588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indent="238125" algn="l" fontAlgn="b">
                        <a:tabLst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psy attempted; lesion too small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972296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solidFill>
                      <a:srgbClr val="C1C2C3">
                        <a:alpha val="8588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indent="238125" algn="l" fontAlgn="b">
                        <a:tabLst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idual disease not amenable to biopsy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505986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solidFill>
                      <a:srgbClr val="C1C2C3">
                        <a:alpha val="8588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indent="238125" algn="l" fontAlgn="b">
                        <a:tabLst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itary lesion, not amenable to biopsy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98735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solidFill>
                      <a:srgbClr val="C1C2C3">
                        <a:alpha val="85882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indent="238125" algn="l" fontAlgn="b">
                        <a:tabLst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psy not safe for patient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421114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9D3D35F-462D-9D7D-2E57-A405A1821D1B}"/>
              </a:ext>
            </a:extLst>
          </p:cNvPr>
          <p:cNvSpPr txBox="1"/>
          <p:nvPr/>
        </p:nvSpPr>
        <p:spPr>
          <a:xfrm>
            <a:off x="208892" y="158343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</a:t>
            </a:r>
          </a:p>
        </p:txBody>
      </p:sp>
    </p:spTree>
    <p:extLst>
      <p:ext uri="{BB962C8B-B14F-4D97-AF65-F5344CB8AC3E}">
        <p14:creationId xmlns:p14="http://schemas.microsoft.com/office/powerpoint/2010/main" val="4207550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596</TotalTime>
  <Words>881</Words>
  <Application>Microsoft Office PowerPoint</Application>
  <PresentationFormat>Widescreen</PresentationFormat>
  <Paragraphs>207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 – PFS/OS</dc:title>
  <dc:creator>Gentzler, Ryan D (rg2uc)</dc:creator>
  <cp:lastModifiedBy>Suzanne Watters</cp:lastModifiedBy>
  <cp:revision>26</cp:revision>
  <cp:lastPrinted>2022-10-21T19:45:58Z</cp:lastPrinted>
  <dcterms:created xsi:type="dcterms:W3CDTF">2022-09-26T02:33:26Z</dcterms:created>
  <dcterms:modified xsi:type="dcterms:W3CDTF">2023-06-06T17:28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e5cb09a-2992-49d6-8ac9-5f63e7b1ad2f_Enabled">
    <vt:lpwstr>true</vt:lpwstr>
  </property>
  <property fmtid="{D5CDD505-2E9C-101B-9397-08002B2CF9AE}" pid="3" name="MSIP_Label_be5cb09a-2992-49d6-8ac9-5f63e7b1ad2f_SetDate">
    <vt:lpwstr>2023-06-06T17:28:29Z</vt:lpwstr>
  </property>
  <property fmtid="{D5CDD505-2E9C-101B-9397-08002B2CF9AE}" pid="4" name="MSIP_Label_be5cb09a-2992-49d6-8ac9-5f63e7b1ad2f_Method">
    <vt:lpwstr>Standard</vt:lpwstr>
  </property>
  <property fmtid="{D5CDD505-2E9C-101B-9397-08002B2CF9AE}" pid="5" name="MSIP_Label_be5cb09a-2992-49d6-8ac9-5f63e7b1ad2f_Name">
    <vt:lpwstr>Controlled</vt:lpwstr>
  </property>
  <property fmtid="{D5CDD505-2E9C-101B-9397-08002B2CF9AE}" pid="6" name="MSIP_Label_be5cb09a-2992-49d6-8ac9-5f63e7b1ad2f_SiteId">
    <vt:lpwstr>91761b62-4c45-43f5-9f0e-be8ad9b551ff</vt:lpwstr>
  </property>
  <property fmtid="{D5CDD505-2E9C-101B-9397-08002B2CF9AE}" pid="7" name="MSIP_Label_be5cb09a-2992-49d6-8ac9-5f63e7b1ad2f_ActionId">
    <vt:lpwstr>e98edc5b-ca4f-4946-809e-5e0c57b240f0</vt:lpwstr>
  </property>
  <property fmtid="{D5CDD505-2E9C-101B-9397-08002B2CF9AE}" pid="8" name="MSIP_Label_be5cb09a-2992-49d6-8ac9-5f63e7b1ad2f_ContentBits">
    <vt:lpwstr>0</vt:lpwstr>
  </property>
</Properties>
</file>